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798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EBD3E1-6326-EAEA-AA4E-CB5664E984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2D0526-7E61-4955-C031-9EA89C7562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DF2C1E-38EC-8B8A-A7BE-EC040CC8A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AADFBC-C91F-5CBC-54B3-4C658984D5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52583A-2352-4C78-86BB-774E98FFE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8537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EE30B9-C040-132F-A1C4-8172C28003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03955B-6253-0D82-33E2-EDD1B7AB28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9A5B06-6F2A-5AE5-BE9C-DD07ECCCD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FEE445-1621-FBC9-E792-43D760986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2369B8-D6CE-27EA-7498-70B34AE5C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1657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880743-1CFB-AC71-338B-581B6772AD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010A6E-5332-4B08-0A1D-0DC9340D06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1D51BD-84B4-7976-24EC-094010A8F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331B07-82A2-E942-D06E-FFC5B0D4C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AF6A76-8A1F-0688-EE6F-2078EAFE5A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75551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F3E397-79D5-30F9-A8C0-F3B86E15F7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9610C1-7A98-BF48-A2AF-683559E1A8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00C6C2-AA6B-EB49-2583-64B6A950F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DCBB0F-A3C7-9429-880E-1FC64B195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791E40-FF26-D932-0EF5-9DDB64776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42211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73D8DF-71DA-8218-28D6-E7EC6AE785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1B982E-D9EE-5835-E4D2-350C5DAE5F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E7E71C-5258-791B-3B64-E2B907D76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4F21D1-DCBC-169D-670B-397A75146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FD0D0E-E25F-538C-3CED-F7DB0DF35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40480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48F06-69FF-335F-695D-069C1F7E31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8A1050-E907-ECD8-155C-B94F545117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3AD79C-6A2F-E8B2-F807-B0ADDE505B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77B32F-B922-FC4C-493F-BEAC651157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9B2302-3A20-03B8-4459-5A6B28CCC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B91015-9DED-EFBE-5779-FCAC1CB78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636486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3F1416-A4CA-1D91-A003-DD2AAF4356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432463-0B34-A737-65BB-F6FCAC0A33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113B73-E643-3092-50C9-836C9273E4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147ECC-A451-466E-6ECB-1BE0B4500B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7076EE5-C818-67D0-7AAB-5F69949C86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D4E11F5-A3FB-42D9-A9D0-EFE909521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0E7305-6858-DBEE-881F-76F2350B1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975E74-89A1-F5D2-9C87-2D7AC19DD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21310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4F422E-8E1D-99B9-8B97-615EF683F8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240BCA1-6E04-5962-505B-0E17E5405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16ACF3-E789-0CEA-3936-FD252725E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920E13-E437-C9B0-D852-7871D0942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36095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46A43E-DC2B-F021-58DF-61A3C4743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57B6230-23B2-2C7D-EF85-43A070D264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B6D0EF5-46BD-D13C-40C4-DAFB822B6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70893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CEBB53-9C26-4294-175C-1D460F48F7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03EC4A-5007-1117-DB6C-A6FDF0C198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1B1829-202B-854C-33F2-199B1F8804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CDE4F7-D23B-5599-8F0A-7F2F10EF1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2A92CD-7C91-D174-09C5-DCC96EDDC5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A75C27-6ECB-2D3D-5FF3-899FB7237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24071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417BF-3F53-8031-0BAB-23C8DE041D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C1DF2B-D017-650A-D31A-5C0EA89939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728D31-D4E1-C75A-3FC7-5C3FD85F98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22918E-FA99-6637-6D5E-D507AFDC5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834CCB-EB1E-B7C4-EC23-60CCAECD9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CC1839-D199-4C5B-37FF-3EA45899E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55112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7C2DD5-AC70-7812-5B43-692C6DB30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DDEA4D-A887-84F0-E009-C3EDB043B3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696AF1-DFBC-6713-64CB-66907C7F6D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A10548-7A20-B0AA-D96C-22CF5C01CC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8D20B0-C719-0828-4564-ACEF025D2E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28580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61206A0-5E45-4DB3-BDEF-3DFE184FEB1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7" t="-212" r="47300" b="46062"/>
          <a:stretch/>
        </p:blipFill>
        <p:spPr bwMode="auto">
          <a:xfrm>
            <a:off x="4036907" y="2478010"/>
            <a:ext cx="3992844" cy="3366535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03422CBE-4C44-42D3-BCC5-5F19087FF367}"/>
              </a:ext>
            </a:extLst>
          </p:cNvPr>
          <p:cNvSpPr/>
          <p:nvPr/>
        </p:nvSpPr>
        <p:spPr>
          <a:xfrm>
            <a:off x="4621555" y="3856383"/>
            <a:ext cx="2816247" cy="24821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02483DE-B39F-4B0C-9562-930644A340D5}"/>
              </a:ext>
            </a:extLst>
          </p:cNvPr>
          <p:cNvSpPr txBox="1"/>
          <p:nvPr/>
        </p:nvSpPr>
        <p:spPr>
          <a:xfrm>
            <a:off x="7738203" y="3826603"/>
            <a:ext cx="7040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3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0CAF130-F139-85C2-C1F7-2926264B6A25}"/>
              </a:ext>
            </a:extLst>
          </p:cNvPr>
          <p:cNvSpPr txBox="1"/>
          <p:nvPr/>
        </p:nvSpPr>
        <p:spPr>
          <a:xfrm>
            <a:off x="998926" y="1031013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2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C5D96AB-B33A-7D31-3829-6A699C3A4CA7}"/>
              </a:ext>
            </a:extLst>
          </p:cNvPr>
          <p:cNvSpPr txBox="1"/>
          <p:nvPr/>
        </p:nvSpPr>
        <p:spPr>
          <a:xfrm rot="16200000">
            <a:off x="4674963" y="2445134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62AFADD-9D27-807D-348C-4125399B9E04}"/>
              </a:ext>
            </a:extLst>
          </p:cNvPr>
          <p:cNvSpPr txBox="1"/>
          <p:nvPr/>
        </p:nvSpPr>
        <p:spPr>
          <a:xfrm rot="16200000">
            <a:off x="5312620" y="1235396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92F3979-76BA-A0F5-DBB2-3855E9262974}"/>
              </a:ext>
            </a:extLst>
          </p:cNvPr>
          <p:cNvSpPr txBox="1"/>
          <p:nvPr/>
        </p:nvSpPr>
        <p:spPr>
          <a:xfrm rot="16200000">
            <a:off x="4853080" y="2156513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C8E6AA-4EBB-9AA3-8986-8338D42E5C2B}"/>
              </a:ext>
            </a:extLst>
          </p:cNvPr>
          <p:cNvSpPr txBox="1"/>
          <p:nvPr/>
        </p:nvSpPr>
        <p:spPr>
          <a:xfrm rot="16200000">
            <a:off x="5612369" y="2036139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51B4B7D-995E-BE3E-8556-87F9252695E7}"/>
              </a:ext>
            </a:extLst>
          </p:cNvPr>
          <p:cNvSpPr txBox="1"/>
          <p:nvPr/>
        </p:nvSpPr>
        <p:spPr>
          <a:xfrm rot="16200000">
            <a:off x="5330758" y="2209263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F5F9917-B2CD-C0E5-0B1F-10859176B702}"/>
              </a:ext>
            </a:extLst>
          </p:cNvPr>
          <p:cNvSpPr txBox="1"/>
          <p:nvPr/>
        </p:nvSpPr>
        <p:spPr>
          <a:xfrm rot="16200000">
            <a:off x="5773466" y="1281653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A16AE6EA-D652-310F-204F-406A942DC8C8}"/>
              </a:ext>
            </a:extLst>
          </p:cNvPr>
          <p:cNvCxnSpPr>
            <a:cxnSpLocks/>
          </p:cNvCxnSpPr>
          <p:nvPr/>
        </p:nvCxnSpPr>
        <p:spPr>
          <a:xfrm>
            <a:off x="4695656" y="2789147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69D956C4-2514-7D44-06FC-958ED87CCC26}"/>
              </a:ext>
            </a:extLst>
          </p:cNvPr>
          <p:cNvCxnSpPr>
            <a:cxnSpLocks/>
          </p:cNvCxnSpPr>
          <p:nvPr/>
        </p:nvCxnSpPr>
        <p:spPr>
          <a:xfrm>
            <a:off x="5159482" y="2789147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6929A9CE-8171-872B-68FD-80DA07CBE68D}"/>
              </a:ext>
            </a:extLst>
          </p:cNvPr>
          <p:cNvCxnSpPr>
            <a:cxnSpLocks/>
          </p:cNvCxnSpPr>
          <p:nvPr/>
        </p:nvCxnSpPr>
        <p:spPr>
          <a:xfrm>
            <a:off x="5620327" y="2788898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B67CF99C-FCF5-5DBE-49CD-6037DC4F8F40}"/>
              </a:ext>
            </a:extLst>
          </p:cNvPr>
          <p:cNvCxnSpPr>
            <a:cxnSpLocks/>
          </p:cNvCxnSpPr>
          <p:nvPr/>
        </p:nvCxnSpPr>
        <p:spPr>
          <a:xfrm>
            <a:off x="6074807" y="2788898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EF2BD7D5-E076-9A78-02A9-A214E48E115C}"/>
              </a:ext>
            </a:extLst>
          </p:cNvPr>
          <p:cNvCxnSpPr>
            <a:cxnSpLocks/>
          </p:cNvCxnSpPr>
          <p:nvPr/>
        </p:nvCxnSpPr>
        <p:spPr>
          <a:xfrm>
            <a:off x="6524456" y="279131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77486BDA-01FB-E645-EFC5-39BD5E6DE6DC}"/>
              </a:ext>
            </a:extLst>
          </p:cNvPr>
          <p:cNvCxnSpPr>
            <a:cxnSpLocks/>
          </p:cNvCxnSpPr>
          <p:nvPr/>
        </p:nvCxnSpPr>
        <p:spPr>
          <a:xfrm>
            <a:off x="6981656" y="2788898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30020DF5-4DE6-0365-6930-42B3202B323E}"/>
              </a:ext>
            </a:extLst>
          </p:cNvPr>
          <p:cNvSpPr txBox="1"/>
          <p:nvPr/>
        </p:nvSpPr>
        <p:spPr>
          <a:xfrm>
            <a:off x="4105416" y="2824816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7CBA123-B0A9-CBD8-C842-DB20183763F5}"/>
              </a:ext>
            </a:extLst>
          </p:cNvPr>
          <p:cNvSpPr txBox="1"/>
          <p:nvPr/>
        </p:nvSpPr>
        <p:spPr>
          <a:xfrm>
            <a:off x="3724611" y="3104283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395DCFE-A340-B632-3E44-529723C7CB68}"/>
              </a:ext>
            </a:extLst>
          </p:cNvPr>
          <p:cNvSpPr txBox="1"/>
          <p:nvPr/>
        </p:nvSpPr>
        <p:spPr>
          <a:xfrm>
            <a:off x="4631051" y="2808090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E7ECCE8-22A7-4BA9-D464-B074799DB421}"/>
              </a:ext>
            </a:extLst>
          </p:cNvPr>
          <p:cNvSpPr txBox="1"/>
          <p:nvPr/>
        </p:nvSpPr>
        <p:spPr>
          <a:xfrm>
            <a:off x="4631051" y="3057476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E8713F14-7274-4BEC-8336-DBDC5437E798}"/>
              </a:ext>
            </a:extLst>
          </p:cNvPr>
          <p:cNvCxnSpPr>
            <a:cxnSpLocks/>
          </p:cNvCxnSpPr>
          <p:nvPr/>
        </p:nvCxnSpPr>
        <p:spPr>
          <a:xfrm>
            <a:off x="4266963" y="4333374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36">
            <a:extLst>
              <a:ext uri="{FF2B5EF4-FFF2-40B4-BE49-F238E27FC236}">
                <a16:creationId xmlns:a16="http://schemas.microsoft.com/office/drawing/2014/main" id="{FD4E685A-AD48-440B-8D9A-F3E10CFAE17B}"/>
              </a:ext>
            </a:extLst>
          </p:cNvPr>
          <p:cNvSpPr txBox="1"/>
          <p:nvPr/>
        </p:nvSpPr>
        <p:spPr>
          <a:xfrm>
            <a:off x="3938577" y="419130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8D863EF0-38AA-403F-87A3-AEEF3A4D26E2}"/>
              </a:ext>
            </a:extLst>
          </p:cNvPr>
          <p:cNvCxnSpPr>
            <a:cxnSpLocks/>
          </p:cNvCxnSpPr>
          <p:nvPr/>
        </p:nvCxnSpPr>
        <p:spPr>
          <a:xfrm>
            <a:off x="4268777" y="4612178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38">
            <a:extLst>
              <a:ext uri="{FF2B5EF4-FFF2-40B4-BE49-F238E27FC236}">
                <a16:creationId xmlns:a16="http://schemas.microsoft.com/office/drawing/2014/main" id="{478B7EB3-192F-40EE-AC6A-9FCD85C94BD7}"/>
              </a:ext>
            </a:extLst>
          </p:cNvPr>
          <p:cNvSpPr txBox="1"/>
          <p:nvPr/>
        </p:nvSpPr>
        <p:spPr>
          <a:xfrm>
            <a:off x="3940391" y="447010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62C0BA1-F56C-44CF-B693-327D60ABEBE0}"/>
              </a:ext>
            </a:extLst>
          </p:cNvPr>
          <p:cNvCxnSpPr>
            <a:cxnSpLocks/>
          </p:cNvCxnSpPr>
          <p:nvPr/>
        </p:nvCxnSpPr>
        <p:spPr>
          <a:xfrm>
            <a:off x="4268246" y="3937318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40">
            <a:extLst>
              <a:ext uri="{FF2B5EF4-FFF2-40B4-BE49-F238E27FC236}">
                <a16:creationId xmlns:a16="http://schemas.microsoft.com/office/drawing/2014/main" id="{AAACB78F-C924-4654-ABB7-B269569E0629}"/>
              </a:ext>
            </a:extLst>
          </p:cNvPr>
          <p:cNvSpPr txBox="1"/>
          <p:nvPr/>
        </p:nvSpPr>
        <p:spPr>
          <a:xfrm>
            <a:off x="3939860" y="379524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593D6652-B5D3-4171-A521-783B6A33E412}"/>
              </a:ext>
            </a:extLst>
          </p:cNvPr>
          <p:cNvCxnSpPr>
            <a:cxnSpLocks/>
          </p:cNvCxnSpPr>
          <p:nvPr/>
        </p:nvCxnSpPr>
        <p:spPr>
          <a:xfrm>
            <a:off x="4266772" y="3710843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42">
            <a:extLst>
              <a:ext uri="{FF2B5EF4-FFF2-40B4-BE49-F238E27FC236}">
                <a16:creationId xmlns:a16="http://schemas.microsoft.com/office/drawing/2014/main" id="{58AEF2BF-0A7A-40E0-9B4F-C2A4758FFF89}"/>
              </a:ext>
            </a:extLst>
          </p:cNvPr>
          <p:cNvSpPr txBox="1"/>
          <p:nvPr/>
        </p:nvSpPr>
        <p:spPr>
          <a:xfrm>
            <a:off x="3938386" y="35620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3262E812-208B-4F8D-8F90-289F61980592}"/>
              </a:ext>
            </a:extLst>
          </p:cNvPr>
          <p:cNvCxnSpPr>
            <a:cxnSpLocks/>
          </p:cNvCxnSpPr>
          <p:nvPr/>
        </p:nvCxnSpPr>
        <p:spPr>
          <a:xfrm>
            <a:off x="4266963" y="5223814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38">
            <a:extLst>
              <a:ext uri="{FF2B5EF4-FFF2-40B4-BE49-F238E27FC236}">
                <a16:creationId xmlns:a16="http://schemas.microsoft.com/office/drawing/2014/main" id="{DA2EEA57-6BD1-4AF1-B6CF-96407B025E72}"/>
              </a:ext>
            </a:extLst>
          </p:cNvPr>
          <p:cNvSpPr txBox="1"/>
          <p:nvPr/>
        </p:nvSpPr>
        <p:spPr>
          <a:xfrm>
            <a:off x="3938577" y="508174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0A772D53-1A0A-4762-8291-F7E5BBAE99D6}"/>
              </a:ext>
            </a:extLst>
          </p:cNvPr>
          <p:cNvCxnSpPr>
            <a:cxnSpLocks/>
          </p:cNvCxnSpPr>
          <p:nvPr/>
        </p:nvCxnSpPr>
        <p:spPr>
          <a:xfrm>
            <a:off x="4266772" y="3580459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TextBox 42">
            <a:extLst>
              <a:ext uri="{FF2B5EF4-FFF2-40B4-BE49-F238E27FC236}">
                <a16:creationId xmlns:a16="http://schemas.microsoft.com/office/drawing/2014/main" id="{569A272D-25F7-4076-84A1-1B023C102567}"/>
              </a:ext>
            </a:extLst>
          </p:cNvPr>
          <p:cNvSpPr txBox="1"/>
          <p:nvPr/>
        </p:nvSpPr>
        <p:spPr>
          <a:xfrm>
            <a:off x="3853426" y="341129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7715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Carvalho Schäfer</dc:creator>
  <cp:lastModifiedBy>mnagata</cp:lastModifiedBy>
  <cp:revision>6</cp:revision>
  <dcterms:created xsi:type="dcterms:W3CDTF">2024-08-13T14:46:47Z</dcterms:created>
  <dcterms:modified xsi:type="dcterms:W3CDTF">2024-08-14T22:22:25Z</dcterms:modified>
</cp:coreProperties>
</file>